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slideshow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57" r:id="rId13"/>
    <p:sldId id="266" r:id="rId14"/>
    <p:sldId id="267" r:id="rId15"/>
    <p:sldId id="269" r:id="rId16"/>
    <p:sldId id="268" r:id="rId17"/>
    <p:sldId id="272" r:id="rId18"/>
    <p:sldId id="270" r:id="rId19"/>
    <p:sldId id="271" r:id="rId20"/>
    <p:sldId id="258" r:id="rId21"/>
  </p:sldIdLst>
  <p:sldSz cx="105156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kiosk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95" autoAdjust="0"/>
  </p:normalViewPr>
  <p:slideViewPr>
    <p:cSldViewPr snapToGrid="0">
      <p:cViewPr varScale="1">
        <p:scale>
          <a:sx n="69" d="100"/>
          <a:sy n="69" d="100"/>
        </p:scale>
        <p:origin x="9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8670" y="1122363"/>
            <a:ext cx="893826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14450" y="3602038"/>
            <a:ext cx="78867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69504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94276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525227" y="365125"/>
            <a:ext cx="2267426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2948" y="365125"/>
            <a:ext cx="6670834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38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878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7471" y="1709740"/>
            <a:ext cx="906970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471" y="4589465"/>
            <a:ext cx="906970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424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2948" y="1825625"/>
            <a:ext cx="446913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23523" y="1825625"/>
            <a:ext cx="446913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1740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4317" y="365127"/>
            <a:ext cx="906970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4318" y="1681163"/>
            <a:ext cx="44485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4318" y="2505075"/>
            <a:ext cx="44485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23523" y="1681163"/>
            <a:ext cx="447050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23523" y="2505075"/>
            <a:ext cx="447050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4271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9330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0336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4317" y="457200"/>
            <a:ext cx="33915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70499" y="987427"/>
            <a:ext cx="532352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4317" y="2057400"/>
            <a:ext cx="33915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180219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4317" y="457200"/>
            <a:ext cx="339155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70499" y="987427"/>
            <a:ext cx="532352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4317" y="2057400"/>
            <a:ext cx="339155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08995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2948" y="365127"/>
            <a:ext cx="906970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948" y="1825625"/>
            <a:ext cx="906970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2948" y="6356352"/>
            <a:ext cx="23660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FCB1E-CF8D-45B1-844E-2BEF43140F73}" type="datetimeFigureOut">
              <a:rPr lang="en-GB" smtClean="0"/>
              <a:t>06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83293" y="6356352"/>
            <a:ext cx="354901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26643" y="6356352"/>
            <a:ext cx="23660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74DEEB-23EE-4EA3-BC55-E1EC576750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6216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16296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Click="0" advTm="1000">
        <p:fade/>
      </p:transition>
    </mc:Choice>
    <mc:Fallback xmlns="">
      <p:transition spd="med" advClick="0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4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1628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4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8797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4" cy="6857999"/>
          </a:xfrm>
          <a:prstGeom prst="rect">
            <a:avLst/>
          </a:prstGeom>
        </p:spPr>
      </p:pic>
      <p:sp>
        <p:nvSpPr>
          <p:cNvPr id="4" name="Oval 3"/>
          <p:cNvSpPr/>
          <p:nvPr/>
        </p:nvSpPr>
        <p:spPr>
          <a:xfrm>
            <a:off x="7455877" y="4756638"/>
            <a:ext cx="123092" cy="114300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89502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81692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32008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35479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509461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49361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4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97111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4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45770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54234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5036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76808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68909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"/>
            <a:ext cx="10482472" cy="6857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78198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"/>
            <a:ext cx="10482474" cy="6857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79642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 advTm="1000">
        <p:fade/>
      </p:transition>
    </mc:Choice>
    <mc:Fallback xmlns="">
      <p:transition spd="med" advTm="1000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69574DCA5E8CEA4E912B7198CE871E35" ma:contentTypeVersion="14" ma:contentTypeDescription="Creare un nuovo documento." ma:contentTypeScope="" ma:versionID="28fbfe5cde90317d443c23b211a7d410">
  <xsd:schema xmlns:xsd="http://www.w3.org/2001/XMLSchema" xmlns:xs="http://www.w3.org/2001/XMLSchema" xmlns:p="http://schemas.microsoft.com/office/2006/metadata/properties" xmlns:ns3="8c2680b1-8717-4e17-af8a-c3c5948a3503" xmlns:ns4="3c9ac98d-36e3-464e-9a3d-571690e2b8cf" targetNamespace="http://schemas.microsoft.com/office/2006/metadata/properties" ma:root="true" ma:fieldsID="e26d00eb25b235407d425d1a57990c0e" ns3:_="" ns4:_="">
    <xsd:import namespace="8c2680b1-8717-4e17-af8a-c3c5948a3503"/>
    <xsd:import namespace="3c9ac98d-36e3-464e-9a3d-571690e2b8cf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  <xsd:element ref="ns3:SharedWithDetails" minOccurs="0"/>
                <xsd:element ref="ns3:SharingHintHash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c2680b1-8717-4e17-af8a-c3c5948a3503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ndiviso con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c9ac98d-36e3-464e-9a3d-571690e2b8c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4" nillable="true" ma:displayName="MediaServiceLocation" ma:internalName="MediaServiceLocation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26DAF29-8398-4E94-985E-E2F285B059B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A3FE595-0B61-4396-B905-B84B6357BD89}">
  <ds:schemaRefs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8c2680b1-8717-4e17-af8a-c3c5948a3503"/>
    <ds:schemaRef ds:uri="http://purl.org/dc/dcmitype/"/>
    <ds:schemaRef ds:uri="http://schemas.microsoft.com/office/infopath/2007/PartnerControls"/>
    <ds:schemaRef ds:uri="3c9ac98d-36e3-464e-9a3d-571690e2b8cf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08275A27-FE20-4FD9-B1CA-8BFB9FC6926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c2680b1-8717-4e17-af8a-c3c5948a3503"/>
    <ds:schemaRef ds:uri="3c9ac98d-36e3-464e-9a3d-571690e2b8c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</TotalTime>
  <Words>0</Words>
  <Application>Microsoft Office PowerPoint</Application>
  <PresentationFormat>Custom</PresentationFormat>
  <Paragraphs>0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AO of the U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cchi, Giuliano (NSAH)</dc:creator>
  <cp:lastModifiedBy>Cecchi, Giuliano (NSAH)</cp:lastModifiedBy>
  <cp:revision>14</cp:revision>
  <dcterms:created xsi:type="dcterms:W3CDTF">2021-05-11T09:16:06Z</dcterms:created>
  <dcterms:modified xsi:type="dcterms:W3CDTF">2021-12-06T15:13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9574DCA5E8CEA4E912B7198CE871E35</vt:lpwstr>
  </property>
</Properties>
</file>